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ezione senza titolo" id="{0DD5DE3D-3245-49E6-9AA7-BFFE7EADF1C2}">
          <p14:sldIdLst>
            <p14:sldId id="256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0121963-C766-F01C-AA89-A4BA5B4E284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FD49CCCE-9690-3B4B-1CA0-B0041CD149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485FE39-DA7F-B9B5-09F7-EF8751D245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0A4B-B9CB-4DCC-B17F-80D3FDF27BD3}" type="datetimeFigureOut">
              <a:rPr lang="it-IT" smtClean="0"/>
              <a:t>05/06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0536899-6878-7000-98D7-9A35C483F0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83E3D02-BB39-7135-986E-0CE8DA0D34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6D69A-94D0-4625-A819-EC77B984F5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58265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29807DC-C6DD-5793-B99C-9B98A592BF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0BF0397-C95D-F5E9-9CCA-32C514A7E3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70A9FAA-CD52-CB28-4920-C5B7D8EFB3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0A4B-B9CB-4DCC-B17F-80D3FDF27BD3}" type="datetimeFigureOut">
              <a:rPr lang="it-IT" smtClean="0"/>
              <a:t>05/06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1141E9A-DB11-B185-98B8-4EDAA8C4CF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E2A73D9-A273-3F13-392D-C6B8CBBED9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6D69A-94D0-4625-A819-EC77B984F5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361340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BDE4827F-397C-E7A2-9947-CFC5CF6FE19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008AC6D9-E2E2-8BCC-536B-7037072087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63C09EC-4543-CFC2-4E13-286F85F8DB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0A4B-B9CB-4DCC-B17F-80D3FDF27BD3}" type="datetimeFigureOut">
              <a:rPr lang="it-IT" smtClean="0"/>
              <a:t>05/06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F9BC72A-9F93-6744-491B-13FDB4B109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F94B216-E8EB-F961-146F-06970A94EF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6D69A-94D0-4625-A819-EC77B984F5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491410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B9F3C72-0450-B78E-B596-FC0F7A6430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85ADF84-8C0F-A3BD-D77F-FE967A6724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4E2FE51-6F59-8787-A10A-5203D9392F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0A4B-B9CB-4DCC-B17F-80D3FDF27BD3}" type="datetimeFigureOut">
              <a:rPr lang="it-IT" smtClean="0"/>
              <a:t>05/06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D78543B-C32B-2EDC-A24B-1981CBA9C0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4385362-8BCC-4140-ADB3-D2BB0650E6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6D69A-94D0-4625-A819-EC77B984F5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00475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5069A08-4BA9-24C0-2ACE-E042799434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9B2BC00-401A-9010-68C2-19E8CC3E0F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29F80CA-00CC-56B2-6EB6-53DD998CF7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0A4B-B9CB-4DCC-B17F-80D3FDF27BD3}" type="datetimeFigureOut">
              <a:rPr lang="it-IT" smtClean="0"/>
              <a:t>05/06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633D5FA-4947-44A2-645A-AFEB74710B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D2A7A9E-40D6-1D9D-70CB-2318C5D4E7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6D69A-94D0-4625-A819-EC77B984F5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85944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263B91D-7C40-B446-1148-EAAA6FBA04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43C7116-DF55-0862-1D39-773C635DB5C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5CD5E77D-B1EE-DA18-A8B8-03F7F447DD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352897A-C9D0-FD0A-ADE3-0D2C1D5C5E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0A4B-B9CB-4DCC-B17F-80D3FDF27BD3}" type="datetimeFigureOut">
              <a:rPr lang="it-IT" smtClean="0"/>
              <a:t>05/06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7B49CAC7-C57C-8011-9261-F7CCF72CD6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67B5BCE-B18F-F323-FDB0-909141F02A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6D69A-94D0-4625-A819-EC77B984F5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549634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5F0854D-C6AB-7DA7-BCF9-A0FFBCFB9E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489E561-98C2-3A51-921F-822F6A1A92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8757ED5-5228-802E-3406-776E6D5ABB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F8FC34EC-AF5B-04F7-89CF-938CEA905DF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36C14F2A-AF8B-F3DF-F063-D61182FC885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60423426-0EDC-13CD-FB67-770B260749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0A4B-B9CB-4DCC-B17F-80D3FDF27BD3}" type="datetimeFigureOut">
              <a:rPr lang="it-IT" smtClean="0"/>
              <a:t>05/06/20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8BE654D9-1E90-4337-735F-AE95D2A9C0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897DF2CE-091F-1831-B9DC-5C64B9DB63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6D69A-94D0-4625-A819-EC77B984F5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92518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A9CCFE2-A3B8-C820-227D-CAF47BDBCC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C7C0FEFD-D527-4F38-C0EB-F917AB2C21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0A4B-B9CB-4DCC-B17F-80D3FDF27BD3}" type="datetimeFigureOut">
              <a:rPr lang="it-IT" smtClean="0"/>
              <a:t>05/06/20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7D47B70D-571B-17F8-265F-B0F2696A7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3BDDADB4-7EC0-6B3F-5664-85576E5635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6D69A-94D0-4625-A819-EC77B984F5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337039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178E279D-64A6-8D77-BBD4-D47A5EC833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0A4B-B9CB-4DCC-B17F-80D3FDF27BD3}" type="datetimeFigureOut">
              <a:rPr lang="it-IT" smtClean="0"/>
              <a:t>05/06/20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67CA6388-6662-0D45-DCA2-83C1192418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714C9854-92E8-FE24-8801-FCCED6BE54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6D69A-94D0-4625-A819-EC77B984F5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67931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2F484EE-4CD6-A9E7-6DC6-9A9C1E29C3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C2C76FE-711D-187B-FCCF-A2D5C167771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CEFBAF6-AD8E-89F5-8DCF-005B9595B7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AE740DD-F9F9-A17A-F44C-024D1F4426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0A4B-B9CB-4DCC-B17F-80D3FDF27BD3}" type="datetimeFigureOut">
              <a:rPr lang="it-IT" smtClean="0"/>
              <a:t>05/06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38CDC2D-5FE5-D4D4-A1E9-B469396E8C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14D0025-B5DD-16F6-115C-3F7999CD7A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6D69A-94D0-4625-A819-EC77B984F5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641340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09FF615-BBF9-36D0-1164-132625AFBC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F4A2EDB4-7458-AA07-4F9D-1621407E557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513F53F1-97E3-A4FF-4AB3-88AACA719F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E15E784-9E2F-D125-4113-612E438DB2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C0A4B-B9CB-4DCC-B17F-80D3FDF27BD3}" type="datetimeFigureOut">
              <a:rPr lang="it-IT" smtClean="0"/>
              <a:t>05/06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9A60B9F-D713-CBBD-958F-7C0F1FDBE0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767C83A-1387-FB1F-C550-82A32B4AD0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06D69A-94D0-4625-A819-EC77B984F5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96739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5F43A1CF-9847-9A40-A32B-4FE8442683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94DCC93-D237-794F-7D83-AFCF3D0896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4ABA2A3-3FEC-D349-ADE2-8DA257BF5D0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4C0A4B-B9CB-4DCC-B17F-80D3FDF27BD3}" type="datetimeFigureOut">
              <a:rPr lang="it-IT" smtClean="0"/>
              <a:t>05/06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8B09E7A-B4D2-8F39-A9D7-6A1D645906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5B0017F-03FE-3536-D269-228E52585A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06D69A-94D0-4625-A819-EC77B984F5C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86518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Immagine 23">
            <a:extLst>
              <a:ext uri="{FF2B5EF4-FFF2-40B4-BE49-F238E27FC236}">
                <a16:creationId xmlns:a16="http://schemas.microsoft.com/office/drawing/2014/main" id="{8442875B-43B3-0476-9B65-5135A6BBF3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6805" y="508126"/>
            <a:ext cx="9297873" cy="5571488"/>
          </a:xfrm>
          <a:prstGeom prst="rect">
            <a:avLst/>
          </a:prstGeom>
        </p:spPr>
      </p:pic>
      <p:sp>
        <p:nvSpPr>
          <p:cNvPr id="18" name="Rettangolo 17">
            <a:extLst>
              <a:ext uri="{FF2B5EF4-FFF2-40B4-BE49-F238E27FC236}">
                <a16:creationId xmlns:a16="http://schemas.microsoft.com/office/drawing/2014/main" id="{FB421734-F4B9-AF4D-C5E9-F62405DC8550}"/>
              </a:ext>
            </a:extLst>
          </p:cNvPr>
          <p:cNvSpPr/>
          <p:nvPr/>
        </p:nvSpPr>
        <p:spPr>
          <a:xfrm flipH="1" flipV="1">
            <a:off x="5180182" y="3479954"/>
            <a:ext cx="5724496" cy="2218226"/>
          </a:xfrm>
          <a:prstGeom prst="rect">
            <a:avLst/>
          </a:prstGeom>
          <a:gradFill flip="none" rotWithShape="1">
            <a:gsLst>
              <a:gs pos="100000">
                <a:srgbClr val="F01212"/>
              </a:gs>
              <a:gs pos="56000">
                <a:srgbClr val="CE0000">
                  <a:alpha val="53000"/>
                  <a:lumMod val="76000"/>
                  <a:lumOff val="24000"/>
                </a:srgbClr>
              </a:gs>
              <a:gs pos="0">
                <a:srgbClr val="FF0101">
                  <a:alpha val="0"/>
                </a:srgbClr>
              </a:gs>
              <a:gs pos="100000">
                <a:srgbClr val="E00C0C"/>
              </a:gs>
              <a:gs pos="100000">
                <a:srgbClr val="C00000">
                  <a:alpha val="97000"/>
                </a:srgbClr>
              </a:gs>
            </a:gsLst>
            <a:lin ang="13200000" scaled="0"/>
            <a:tileRect/>
          </a:gradFill>
          <a:ln>
            <a:noFill/>
          </a:ln>
          <a:effectLst>
            <a:outerShdw blurRad="1270000" dist="1003300" dir="13320000" sx="29000" sy="29000" algn="br" rotWithShape="0">
              <a:srgbClr val="FF0101">
                <a:alpha val="0"/>
              </a:srgb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4" name="TextBox 5">
            <a:extLst>
              <a:ext uri="{FF2B5EF4-FFF2-40B4-BE49-F238E27FC236}">
                <a16:creationId xmlns:a16="http://schemas.microsoft.com/office/drawing/2014/main" id="{B53C4DEB-F542-29E3-B2F1-5E82D504B285}"/>
              </a:ext>
            </a:extLst>
          </p:cNvPr>
          <p:cNvSpPr txBox="1"/>
          <p:nvPr/>
        </p:nvSpPr>
        <p:spPr>
          <a:xfrm>
            <a:off x="5218524" y="6190733"/>
            <a:ext cx="1326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MLA (mm²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2677278-51B8-A11A-7BAE-40984EE05F38}"/>
              </a:ext>
            </a:extLst>
          </p:cNvPr>
          <p:cNvSpPr txBox="1"/>
          <p:nvPr/>
        </p:nvSpPr>
        <p:spPr>
          <a:xfrm rot="16200000">
            <a:off x="546277" y="2874616"/>
            <a:ext cx="633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FFR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Table 2">
            <a:extLst>
              <a:ext uri="{FF2B5EF4-FFF2-40B4-BE49-F238E27FC236}">
                <a16:creationId xmlns:a16="http://schemas.microsoft.com/office/drawing/2014/main" id="{5F776D38-B202-E22A-6FA2-8E008B44EE8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82928709"/>
              </p:ext>
            </p:extLst>
          </p:nvPr>
        </p:nvGraphicFramePr>
        <p:xfrm>
          <a:off x="1010728" y="487578"/>
          <a:ext cx="711201" cy="553249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11201">
                  <a:extLst>
                    <a:ext uri="{9D8B030D-6E8A-4147-A177-3AD203B41FA5}">
                      <a16:colId xmlns:a16="http://schemas.microsoft.com/office/drawing/2014/main" val="2763647006"/>
                    </a:ext>
                  </a:extLst>
                </a:gridCol>
              </a:tblGrid>
              <a:tr h="691562">
                <a:tc>
                  <a:txBody>
                    <a:bodyPr/>
                    <a:lstStyle/>
                    <a:p>
                      <a:r>
                        <a:rPr lang="it-IT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  <a:endParaRPr lang="en-US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64699742"/>
                  </a:ext>
                </a:extLst>
              </a:tr>
              <a:tr h="691562">
                <a:tc>
                  <a:txBody>
                    <a:bodyPr/>
                    <a:lstStyle/>
                    <a:p>
                      <a:r>
                        <a:rPr lang="it-IT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</a:t>
                      </a:r>
                      <a:endParaRPr lang="en-US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0460075"/>
                  </a:ext>
                </a:extLst>
              </a:tr>
              <a:tr h="691562">
                <a:tc>
                  <a:txBody>
                    <a:bodyPr/>
                    <a:lstStyle/>
                    <a:p>
                      <a:r>
                        <a:rPr lang="it-IT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</a:t>
                      </a:r>
                      <a:endParaRPr lang="en-US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81468280"/>
                  </a:ext>
                </a:extLst>
              </a:tr>
              <a:tr h="691562">
                <a:tc>
                  <a:txBody>
                    <a:bodyPr/>
                    <a:lstStyle/>
                    <a:p>
                      <a:r>
                        <a:rPr lang="it-IT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</a:t>
                      </a:r>
                      <a:endParaRPr lang="en-US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08223152"/>
                  </a:ext>
                </a:extLst>
              </a:tr>
              <a:tr h="691562">
                <a:tc>
                  <a:txBody>
                    <a:bodyPr/>
                    <a:lstStyle/>
                    <a:p>
                      <a:r>
                        <a:rPr lang="it-IT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</a:t>
                      </a:r>
                      <a:endParaRPr lang="en-US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55096489"/>
                  </a:ext>
                </a:extLst>
              </a:tr>
              <a:tr h="691562">
                <a:tc>
                  <a:txBody>
                    <a:bodyPr/>
                    <a:lstStyle/>
                    <a:p>
                      <a:r>
                        <a:rPr lang="it-IT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</a:t>
                      </a:r>
                      <a:endParaRPr lang="en-US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28157789"/>
                  </a:ext>
                </a:extLst>
              </a:tr>
              <a:tr h="691562">
                <a:tc>
                  <a:txBody>
                    <a:bodyPr/>
                    <a:lstStyle/>
                    <a:p>
                      <a:r>
                        <a:rPr lang="it-IT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</a:t>
                      </a:r>
                      <a:endParaRPr lang="en-US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56403051"/>
                  </a:ext>
                </a:extLst>
              </a:tr>
              <a:tr h="691562">
                <a:tc>
                  <a:txBody>
                    <a:bodyPr/>
                    <a:lstStyle/>
                    <a:p>
                      <a:r>
                        <a:rPr lang="it-IT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</a:t>
                      </a:r>
                      <a:endParaRPr lang="en-US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67727721"/>
                  </a:ext>
                </a:extLst>
              </a:tr>
            </a:tbl>
          </a:graphicData>
        </a:graphic>
      </p:graphicFrame>
      <p:sp>
        <p:nvSpPr>
          <p:cNvPr id="8" name="CasellaDiTesto 7">
            <a:extLst>
              <a:ext uri="{FF2B5EF4-FFF2-40B4-BE49-F238E27FC236}">
                <a16:creationId xmlns:a16="http://schemas.microsoft.com/office/drawing/2014/main" id="{294C9204-8A9F-A06F-00AB-18BD017DBED6}"/>
              </a:ext>
            </a:extLst>
          </p:cNvPr>
          <p:cNvSpPr txBox="1"/>
          <p:nvPr/>
        </p:nvSpPr>
        <p:spPr>
          <a:xfrm>
            <a:off x="6218111" y="5085760"/>
            <a:ext cx="2544945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REVERSE MISMATCH = </a:t>
            </a:r>
          </a:p>
          <a:p>
            <a:pPr algn="ctr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UNDERTREATMENT RISK</a:t>
            </a:r>
            <a:endParaRPr lang="it-IT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it-IT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ttangolo 8">
            <a:extLst>
              <a:ext uri="{FF2B5EF4-FFF2-40B4-BE49-F238E27FC236}">
                <a16:creationId xmlns:a16="http://schemas.microsoft.com/office/drawing/2014/main" id="{ABFB95E0-1B34-0507-91C6-756BD43527DC}"/>
              </a:ext>
            </a:extLst>
          </p:cNvPr>
          <p:cNvSpPr/>
          <p:nvPr/>
        </p:nvSpPr>
        <p:spPr>
          <a:xfrm>
            <a:off x="1741080" y="610290"/>
            <a:ext cx="3477444" cy="2856430"/>
          </a:xfrm>
          <a:prstGeom prst="rect">
            <a:avLst/>
          </a:prstGeom>
          <a:gradFill flip="none" rotWithShape="1">
            <a:gsLst>
              <a:gs pos="100000">
                <a:srgbClr val="F01212"/>
              </a:gs>
              <a:gs pos="40000">
                <a:srgbClr val="CE0000">
                  <a:alpha val="53000"/>
                  <a:lumMod val="76000"/>
                  <a:lumOff val="24000"/>
                </a:srgbClr>
              </a:gs>
              <a:gs pos="0">
                <a:srgbClr val="FF0101">
                  <a:alpha val="0"/>
                </a:srgbClr>
              </a:gs>
              <a:gs pos="100000">
                <a:srgbClr val="E00C0C"/>
              </a:gs>
              <a:gs pos="100000">
                <a:srgbClr val="C00000">
                  <a:alpha val="97000"/>
                </a:srgbClr>
              </a:gs>
            </a:gsLst>
            <a:lin ang="13200000" scaled="0"/>
            <a:tileRect/>
          </a:gradFill>
          <a:ln>
            <a:noFill/>
          </a:ln>
          <a:effectLst>
            <a:outerShdw blurRad="1270000" dist="1003300" dir="13320000" sx="29000" sy="29000" algn="br" rotWithShape="0">
              <a:srgbClr val="FF0101">
                <a:alpha val="0"/>
              </a:srgb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14188D44-CD46-596A-7235-0223D03A5887}"/>
              </a:ext>
            </a:extLst>
          </p:cNvPr>
          <p:cNvSpPr txBox="1"/>
          <p:nvPr/>
        </p:nvSpPr>
        <p:spPr>
          <a:xfrm>
            <a:off x="9874085" y="5321261"/>
            <a:ext cx="1271158" cy="3757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FALSE -</a:t>
            </a:r>
            <a:endParaRPr lang="it-IT" dirty="0"/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D0E2F103-84BA-0B44-13B7-C6A657745856}"/>
              </a:ext>
            </a:extLst>
          </p:cNvPr>
          <p:cNvSpPr txBox="1"/>
          <p:nvPr/>
        </p:nvSpPr>
        <p:spPr>
          <a:xfrm>
            <a:off x="1902057" y="1075765"/>
            <a:ext cx="2330086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MISMATCH = OVERTREATMENT RISK</a:t>
            </a:r>
            <a:endParaRPr lang="it-IT" sz="1400" b="1" dirty="0"/>
          </a:p>
        </p:txBody>
      </p:sp>
      <p:sp>
        <p:nvSpPr>
          <p:cNvPr id="12" name="Rettangolo 11">
            <a:extLst>
              <a:ext uri="{FF2B5EF4-FFF2-40B4-BE49-F238E27FC236}">
                <a16:creationId xmlns:a16="http://schemas.microsoft.com/office/drawing/2014/main" id="{5AC806F9-DCEB-E85C-DCED-BA24A78A621E}"/>
              </a:ext>
            </a:extLst>
          </p:cNvPr>
          <p:cNvSpPr/>
          <p:nvPr/>
        </p:nvSpPr>
        <p:spPr>
          <a:xfrm>
            <a:off x="1741080" y="3466720"/>
            <a:ext cx="3457742" cy="2218226"/>
          </a:xfrm>
          <a:prstGeom prst="rect">
            <a:avLst/>
          </a:prstGeom>
          <a:gradFill flip="none" rotWithShape="1">
            <a:gsLst>
              <a:gs pos="0">
                <a:schemeClr val="accent6">
                  <a:lumMod val="75000"/>
                  <a:alpha val="0"/>
                </a:schemeClr>
              </a:gs>
              <a:gs pos="100000">
                <a:srgbClr val="92D050">
                  <a:alpha val="65000"/>
                </a:srgbClr>
              </a:gs>
            </a:gsLst>
            <a:lin ang="8100000" scaled="1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C32FD6E4-AC85-E8C6-7591-4A8ADC1930E5}"/>
              </a:ext>
            </a:extLst>
          </p:cNvPr>
          <p:cNvSpPr txBox="1"/>
          <p:nvPr/>
        </p:nvSpPr>
        <p:spPr>
          <a:xfrm>
            <a:off x="1904881" y="575169"/>
            <a:ext cx="153818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FALSE +</a:t>
            </a:r>
            <a:endParaRPr lang="it-IT" dirty="0"/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A6092442-65EE-0679-8AFA-C6AEAF2F60E9}"/>
              </a:ext>
            </a:extLst>
          </p:cNvPr>
          <p:cNvSpPr txBox="1"/>
          <p:nvPr/>
        </p:nvSpPr>
        <p:spPr>
          <a:xfrm>
            <a:off x="1902057" y="5328173"/>
            <a:ext cx="153818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TRUE +</a:t>
            </a:r>
            <a:endParaRPr lang="it-IT" dirty="0"/>
          </a:p>
        </p:txBody>
      </p:sp>
      <p:sp>
        <p:nvSpPr>
          <p:cNvPr id="15" name="Rettangolo 14">
            <a:extLst>
              <a:ext uri="{FF2B5EF4-FFF2-40B4-BE49-F238E27FC236}">
                <a16:creationId xmlns:a16="http://schemas.microsoft.com/office/drawing/2014/main" id="{891A727C-AE8F-0C6D-93E7-DA4542900B50}"/>
              </a:ext>
            </a:extLst>
          </p:cNvPr>
          <p:cNvSpPr/>
          <p:nvPr/>
        </p:nvSpPr>
        <p:spPr>
          <a:xfrm>
            <a:off x="5237675" y="586621"/>
            <a:ext cx="5677277" cy="2903607"/>
          </a:xfrm>
          <a:prstGeom prst="rect">
            <a:avLst/>
          </a:prstGeom>
          <a:gradFill flip="none" rotWithShape="1">
            <a:gsLst>
              <a:gs pos="0">
                <a:schemeClr val="accent6">
                  <a:lumMod val="75000"/>
                  <a:alpha val="0"/>
                </a:schemeClr>
              </a:gs>
              <a:gs pos="100000">
                <a:srgbClr val="92D050">
                  <a:alpha val="70000"/>
                </a:srgbClr>
              </a:gs>
            </a:gsLst>
            <a:lin ang="18900000" scaled="1"/>
            <a:tileRect/>
          </a:gradFill>
          <a:ln>
            <a:noFill/>
          </a:ln>
          <a:effectLst>
            <a:outerShdw blurRad="279400" dist="101600" algn="l" rotWithShape="0">
              <a:prstClr val="black">
                <a:alpha val="19000"/>
              </a:prstClr>
            </a:outerShdw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984E294F-4943-6FBF-3C29-4E5CA0120EAB}"/>
              </a:ext>
            </a:extLst>
          </p:cNvPr>
          <p:cNvSpPr txBox="1"/>
          <p:nvPr/>
        </p:nvSpPr>
        <p:spPr>
          <a:xfrm>
            <a:off x="10030242" y="563165"/>
            <a:ext cx="10493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TRUE -</a:t>
            </a:r>
            <a:endParaRPr lang="it-IT" dirty="0"/>
          </a:p>
        </p:txBody>
      </p:sp>
      <p:sp>
        <p:nvSpPr>
          <p:cNvPr id="17" name="CasellaDiTesto 2"/>
          <p:cNvSpPr txBox="1"/>
          <p:nvPr/>
        </p:nvSpPr>
        <p:spPr>
          <a:xfrm>
            <a:off x="0" y="2"/>
            <a:ext cx="27316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b="1" dirty="0" err="1" smtClean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Supplementary</a:t>
            </a:r>
            <a:r>
              <a:rPr lang="it-IT" b="1" dirty="0" smtClean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Figure 1</a:t>
            </a:r>
            <a:endParaRPr lang="it-IT" b="1" dirty="0">
              <a:latin typeface="Cambria" panose="02040503050406030204" pitchFamily="18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751051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eonardo Grisafi</dc:creator>
  <cp:lastModifiedBy>Grisafi Leonardo-Dir med (&lt; 5)</cp:lastModifiedBy>
  <cp:revision>7</cp:revision>
  <dcterms:created xsi:type="dcterms:W3CDTF">2025-05-14T17:24:36Z</dcterms:created>
  <dcterms:modified xsi:type="dcterms:W3CDTF">2025-06-05T09:01:46Z</dcterms:modified>
</cp:coreProperties>
</file>